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MOU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95DBE66-0901-4AC2-BCDD-965C94363A67}" v="6" dt="2025-11-28T10:22:05.99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785"/>
    <p:restoredTop sz="94675"/>
  </p:normalViewPr>
  <p:slideViewPr>
    <p:cSldViewPr snapToGrid="0">
      <p:cViewPr varScale="1">
        <p:scale>
          <a:sx n="82" d="100"/>
          <a:sy n="82" d="100"/>
        </p:scale>
        <p:origin x="388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shifumi miyagi" userId="6b7c3d3c037d1573" providerId="LiveId" clId="{3BC3974B-B415-420A-92A4-331621E7BB93}"/>
    <pc:docChg chg="undo custSel addSld delSld modSld">
      <pc:chgData name="yoshifumi miyagi" userId="6b7c3d3c037d1573" providerId="LiveId" clId="{3BC3974B-B415-420A-92A4-331621E7BB93}" dt="2025-11-28T16:42:04.822" v="399" actId="947"/>
      <pc:docMkLst>
        <pc:docMk/>
      </pc:docMkLst>
      <pc:sldChg chg="del">
        <pc:chgData name="yoshifumi miyagi" userId="6b7c3d3c037d1573" providerId="LiveId" clId="{3BC3974B-B415-420A-92A4-331621E7BB93}" dt="2025-11-28T16:41:29.028" v="393" actId="2696"/>
        <pc:sldMkLst>
          <pc:docMk/>
          <pc:sldMk cId="2630843928" sldId="256"/>
        </pc:sldMkLst>
      </pc:sldChg>
      <pc:sldChg chg="addSp delSp modSp new del mod">
        <pc:chgData name="yoshifumi miyagi" userId="6b7c3d3c037d1573" providerId="LiveId" clId="{3BC3974B-B415-420A-92A4-331621E7BB93}" dt="2025-11-28T16:41:31.812" v="394" actId="2696"/>
        <pc:sldMkLst>
          <pc:docMk/>
          <pc:sldMk cId="1439060080" sldId="257"/>
        </pc:sldMkLst>
        <pc:spChg chg="del">
          <ac:chgData name="yoshifumi miyagi" userId="6b7c3d3c037d1573" providerId="LiveId" clId="{3BC3974B-B415-420A-92A4-331621E7BB93}" dt="2025-11-28T10:14:37.982" v="2" actId="478"/>
          <ac:spMkLst>
            <pc:docMk/>
            <pc:sldMk cId="1439060080" sldId="257"/>
            <ac:spMk id="2" creationId="{E5EA8731-6DA9-F9D4-C390-398A2367F196}"/>
          </ac:spMkLst>
        </pc:spChg>
        <pc:spChg chg="del">
          <ac:chgData name="yoshifumi miyagi" userId="6b7c3d3c037d1573" providerId="LiveId" clId="{3BC3974B-B415-420A-92A4-331621E7BB93}" dt="2025-11-28T10:14:36.530" v="1" actId="478"/>
          <ac:spMkLst>
            <pc:docMk/>
            <pc:sldMk cId="1439060080" sldId="257"/>
            <ac:spMk id="3" creationId="{ABE6D269-3896-1360-ADDE-F86A0D7780C7}"/>
          </ac:spMkLst>
        </pc:spChg>
        <pc:spChg chg="add mod">
          <ac:chgData name="yoshifumi miyagi" userId="6b7c3d3c037d1573" providerId="LiveId" clId="{3BC3974B-B415-420A-92A4-331621E7BB93}" dt="2025-11-28T10:14:59.213" v="3"/>
          <ac:spMkLst>
            <pc:docMk/>
            <pc:sldMk cId="1439060080" sldId="257"/>
            <ac:spMk id="5" creationId="{E47E0FC6-77BF-EF70-DC9E-066352D10053}"/>
          </ac:spMkLst>
        </pc:spChg>
        <pc:spChg chg="add mod">
          <ac:chgData name="yoshifumi miyagi" userId="6b7c3d3c037d1573" providerId="LiveId" clId="{3BC3974B-B415-420A-92A4-331621E7BB93}" dt="2025-11-28T10:21:59.864" v="117" actId="1076"/>
          <ac:spMkLst>
            <pc:docMk/>
            <pc:sldMk cId="1439060080" sldId="257"/>
            <ac:spMk id="6" creationId="{571365D8-558A-17B5-8374-D46EB078946B}"/>
          </ac:spMkLst>
        </pc:spChg>
        <pc:spChg chg="add mod">
          <ac:chgData name="yoshifumi miyagi" userId="6b7c3d3c037d1573" providerId="LiveId" clId="{3BC3974B-B415-420A-92A4-331621E7BB93}" dt="2025-11-28T10:19:31.377" v="88" actId="20577"/>
          <ac:spMkLst>
            <pc:docMk/>
            <pc:sldMk cId="1439060080" sldId="257"/>
            <ac:spMk id="7" creationId="{37A0F873-27B4-B691-69DE-1316A2485598}"/>
          </ac:spMkLst>
        </pc:spChg>
        <pc:spChg chg="add mod">
          <ac:chgData name="yoshifumi miyagi" userId="6b7c3d3c037d1573" providerId="LiveId" clId="{3BC3974B-B415-420A-92A4-331621E7BB93}" dt="2025-11-28T10:19:34.950" v="90" actId="20577"/>
          <ac:spMkLst>
            <pc:docMk/>
            <pc:sldMk cId="1439060080" sldId="257"/>
            <ac:spMk id="8" creationId="{395088F1-EA94-B569-9E2E-9CC8A15788AC}"/>
          </ac:spMkLst>
        </pc:spChg>
        <pc:spChg chg="add mod">
          <ac:chgData name="yoshifumi miyagi" userId="6b7c3d3c037d1573" providerId="LiveId" clId="{3BC3974B-B415-420A-92A4-331621E7BB93}" dt="2025-11-28T11:01:00.433" v="151" actId="1076"/>
          <ac:spMkLst>
            <pc:docMk/>
            <pc:sldMk cId="1439060080" sldId="257"/>
            <ac:spMk id="13" creationId="{67FA69FC-391C-724F-CBD0-A1A5AC44DD31}"/>
          </ac:spMkLst>
        </pc:spChg>
        <pc:spChg chg="add mod">
          <ac:chgData name="yoshifumi miyagi" userId="6b7c3d3c037d1573" providerId="LiveId" clId="{3BC3974B-B415-420A-92A4-331621E7BB93}" dt="2025-11-28T10:22:30.734" v="149" actId="1076"/>
          <ac:spMkLst>
            <pc:docMk/>
            <pc:sldMk cId="1439060080" sldId="257"/>
            <ac:spMk id="14" creationId="{56E54AB9-095D-9539-449D-5C4D55E3711C}"/>
          </ac:spMkLst>
        </pc:spChg>
        <pc:picChg chg="add mod">
          <ac:chgData name="yoshifumi miyagi" userId="6b7c3d3c037d1573" providerId="LiveId" clId="{3BC3974B-B415-420A-92A4-331621E7BB93}" dt="2025-11-28T10:19:08.419" v="82" actId="1076"/>
          <ac:picMkLst>
            <pc:docMk/>
            <pc:sldMk cId="1439060080" sldId="257"/>
            <ac:picMk id="4" creationId="{5CAC18A7-7F8B-D5C3-4B11-8002F7ADCC9B}"/>
          </ac:picMkLst>
        </pc:picChg>
        <pc:picChg chg="add mod modCrop">
          <ac:chgData name="yoshifumi miyagi" userId="6b7c3d3c037d1573" providerId="LiveId" clId="{3BC3974B-B415-420A-92A4-331621E7BB93}" dt="2025-11-28T10:21:36.021" v="107" actId="732"/>
          <ac:picMkLst>
            <pc:docMk/>
            <pc:sldMk cId="1439060080" sldId="257"/>
            <ac:picMk id="10" creationId="{F3296025-F25D-5199-6B24-3FB6E2C58A3B}"/>
          </ac:picMkLst>
        </pc:picChg>
        <pc:picChg chg="add mod modCrop">
          <ac:chgData name="yoshifumi miyagi" userId="6b7c3d3c037d1573" providerId="LiveId" clId="{3BC3974B-B415-420A-92A4-331621E7BB93}" dt="2025-11-28T10:21:25.451" v="106" actId="732"/>
          <ac:picMkLst>
            <pc:docMk/>
            <pc:sldMk cId="1439060080" sldId="257"/>
            <ac:picMk id="12" creationId="{930EE3CD-9DF1-C0F4-52B1-DF3C453F0BCF}"/>
          </ac:picMkLst>
        </pc:picChg>
      </pc:sldChg>
      <pc:sldChg chg="addSp delSp modSp new mod">
        <pc:chgData name="yoshifumi miyagi" userId="6b7c3d3c037d1573" providerId="LiveId" clId="{3BC3974B-B415-420A-92A4-331621E7BB93}" dt="2025-11-28T16:42:04.822" v="399" actId="947"/>
        <pc:sldMkLst>
          <pc:docMk/>
          <pc:sldMk cId="2954096950" sldId="258"/>
        </pc:sldMkLst>
        <pc:spChg chg="del">
          <ac:chgData name="yoshifumi miyagi" userId="6b7c3d3c037d1573" providerId="LiveId" clId="{3BC3974B-B415-420A-92A4-331621E7BB93}" dt="2025-11-28T11:02:47.820" v="156" actId="478"/>
          <ac:spMkLst>
            <pc:docMk/>
            <pc:sldMk cId="2954096950" sldId="258"/>
            <ac:spMk id="2" creationId="{3900EEE1-9B1B-B2F5-8947-3B36E68DD757}"/>
          </ac:spMkLst>
        </pc:spChg>
        <pc:spChg chg="del">
          <ac:chgData name="yoshifumi miyagi" userId="6b7c3d3c037d1573" providerId="LiveId" clId="{3BC3974B-B415-420A-92A4-331621E7BB93}" dt="2025-11-28T11:02:04.794" v="153" actId="3680"/>
          <ac:spMkLst>
            <pc:docMk/>
            <pc:sldMk cId="2954096950" sldId="258"/>
            <ac:spMk id="3" creationId="{3B991E6A-0A85-9299-DF81-0EEB122097FB}"/>
          </ac:spMkLst>
        </pc:spChg>
        <pc:graphicFrameChg chg="add mod ord modGraphic">
          <ac:chgData name="yoshifumi miyagi" userId="6b7c3d3c037d1573" providerId="LiveId" clId="{3BC3974B-B415-420A-92A4-331621E7BB93}" dt="2025-11-28T16:42:04.822" v="399" actId="947"/>
          <ac:graphicFrameMkLst>
            <pc:docMk/>
            <pc:sldMk cId="2954096950" sldId="258"/>
            <ac:graphicFrameMk id="4" creationId="{B84BBA16-99F3-D8A1-03D5-48B543BDC4B2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3EA7C6-226A-8616-3660-83CA0258B6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30ABB76-83E1-241A-8D2A-2AE9072C3E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9621D6-605A-2942-F46B-7D2F4A460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ADD614-8A70-6AC1-C592-FCC924D13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0CCF0E-3FBA-B7AD-72B2-155853B6C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505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5180FC-53FF-C129-E4ED-6E18E84D0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D30A4C3-E1C5-74FB-4566-57436CD496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ACBA9F-39AC-357C-1CD0-59C92737F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8928B7-EA53-08A5-1C13-F782B1088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CB5C32-3BF5-9B96-DD8E-2CFFF147B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654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0087AE5-6708-7A45-9F5E-6B5BBD4318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7F5821C-A8B3-36C6-6B87-C1DC57D677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9345D4-6EC2-858C-3600-19D033AD3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D59CF8-5002-C0E3-33B5-AE7BDC575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5B43AE-4C74-460E-AECE-7102B600D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880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AA18C0-F1A2-067F-802E-C976421DD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7CD740-00AB-A6B6-121C-A3913D4C85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831107-90C8-1D8A-49C5-A51810E0C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44A84A-23DF-D7D6-D948-DB9CA8E61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0D6FC2-4799-3B96-BD8B-FE6DFC504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741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88B404-EC7F-29A8-F3E8-1D2E25C46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618735-2D33-0E90-2A1C-3E3FE9308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2EAA39-577B-EADC-F311-84DC031B1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0EEA49-99F2-3569-F7EA-7FADCADB5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492056-5161-DD70-D0AE-336BF5E08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17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B1F321-FE2C-A787-17B9-B94E03355F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7D55D3-0A4A-77DE-5BA9-AED5586CF5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8A97C1E-61FB-F2AC-FC12-9BC449F4CB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CDAE7E4-BE82-7F0B-09C4-05E60CE0B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6A7D19-7B96-DB65-8A72-1D1A93231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C7975E-EE28-ABA7-8304-4F56D8310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410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498451-0BAF-F360-3410-B02EE42CEF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F42978-4930-4F08-79C8-D6E1AB4CB0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9577C2C-72B1-A554-DD3E-AFCAE766AC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2316470-744A-8C85-49E0-3C539C1EBA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6CAC358-EB02-D6A1-544C-2AE8B2D6E2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2B4D40D-67F1-EB81-6C37-B6E4C1FFE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22C1664-F18A-B7F0-EA14-0B7184398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128A70F-040B-8C87-05AE-0676CFBFC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4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89B6F1-384F-0F3D-AE1E-C48EF69F0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B5BA296-DA93-57B7-95AA-7F73B38C2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9D5DC0-F85E-EEBA-18FA-DFB2094BE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08AEC63-3D16-24D8-D5D6-D0521F223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90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84BAE7E-6621-0BDF-CE33-2CF226389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BCDDC0-45DC-6EB6-E47A-934BDA30D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2DDCE22-1C71-56D2-52FA-99A0F7E47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940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235C49-9C3E-FE3A-031A-9BD536F1B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4C3570-738F-5D37-B845-5BC1946925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222F412-8B54-D411-594D-46AAFAAA9B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C476F1-CA75-3D61-F542-3A6BC0B59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CE4DD8-39DE-1EA9-E837-CD928F64B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0CAE4B-3F14-EAB9-FC5D-4A2DCF00E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126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D73B82-D4D3-4129-2AB9-87A1D78250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473641C-C804-4C1F-53C8-3594CE100A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EF7358E-93A4-7E68-F2DF-6E384CC0B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CAA45F-AA7F-9A00-5367-D7135E814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81A765-2700-45AC-E515-E3641F361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E1E5745-4FB1-0C57-3717-1A3F255FC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010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A511DAA-B026-9590-DC68-7D007DEF6F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E73DBB7-E52B-F495-2833-1508E68CC7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BFC93A-08B4-9584-FAEF-B9E0FFA0C9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E1D67F-866D-4946-87B2-7B00EA18FD1B}" type="datetimeFigureOut">
              <a:rPr kumimoji="1" lang="ja-JP" altLang="en-US" smtClean="0"/>
              <a:t>2025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1175C7-5FF8-D76E-EF93-DCA8C6BE87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CE6CF6F-9796-E4D0-B7EE-088EB2E008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D28771-79FF-46E7-BC6E-D9ECC8D227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095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B84BBA16-99F3-D8A1-03D5-48B543BDC4B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18156033"/>
              </p:ext>
            </p:extLst>
          </p:nvPr>
        </p:nvGraphicFramePr>
        <p:xfrm>
          <a:off x="838200" y="1210733"/>
          <a:ext cx="10515600" cy="4470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257800">
                  <a:extLst>
                    <a:ext uri="{9D8B030D-6E8A-4147-A177-3AD203B41FA5}">
                      <a16:colId xmlns:a16="http://schemas.microsoft.com/office/drawing/2014/main" val="3130163264"/>
                    </a:ext>
                  </a:extLst>
                </a:gridCol>
                <a:gridCol w="5257800">
                  <a:extLst>
                    <a:ext uri="{9D8B030D-6E8A-4147-A177-3AD203B41FA5}">
                      <a16:colId xmlns:a16="http://schemas.microsoft.com/office/drawing/2014/main" val="3886353182"/>
                    </a:ext>
                  </a:extLst>
                </a:gridCol>
              </a:tblGrid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Continuous variables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VIF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9693789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Weight (k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3.7703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5797569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Height (cm)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3.379765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055494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Age (months)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3.362379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321562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Respiratory rate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1.099933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967759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SpO</a:t>
                      </a:r>
                      <a:r>
                        <a:rPr kumimoji="1" lang="en-US" altLang="ja-JP" sz="2400" baseline="-25000" dirty="0"/>
                        <a:t>2</a:t>
                      </a:r>
                      <a:r>
                        <a:rPr kumimoji="1" lang="en-US" altLang="ja-JP" sz="2400" dirty="0"/>
                        <a:t> at admission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1.079276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1892068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Heart rate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1.043937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5924123"/>
                  </a:ext>
                </a:extLst>
              </a:tr>
              <a:tr h="558800"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Axillary temperature (</a:t>
                      </a:r>
                      <a:r>
                        <a:rPr kumimoji="1" lang="ja-JP" altLang="en-US" sz="2400" dirty="0"/>
                        <a:t>℃</a:t>
                      </a:r>
                      <a:r>
                        <a:rPr kumimoji="1" lang="en-US" altLang="ja-JP" sz="2400" dirty="0"/>
                        <a:t>)</a:t>
                      </a:r>
                      <a:endParaRPr kumimoji="1" lang="ja-JP" alt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2400" dirty="0"/>
                        <a:t>1.031180</a:t>
                      </a:r>
                      <a:endParaRPr kumimoji="1" lang="ja-JP" altLang="en-US" sz="2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43474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4096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34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oshifumi miyagi</dc:creator>
  <cp:lastModifiedBy>yoshifumi miyagi</cp:lastModifiedBy>
  <cp:revision>2</cp:revision>
  <dcterms:created xsi:type="dcterms:W3CDTF">2025-08-23T00:43:54Z</dcterms:created>
  <dcterms:modified xsi:type="dcterms:W3CDTF">2025-11-28T16:42:13Z</dcterms:modified>
</cp:coreProperties>
</file>